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96" r:id="rId2"/>
    <p:sldId id="29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00D0"/>
    <a:srgbClr val="D00000"/>
    <a:srgbClr val="EE00A4"/>
    <a:srgbClr val="D60093"/>
    <a:srgbClr val="64D42C"/>
    <a:srgbClr val="209C64"/>
    <a:srgbClr val="DAB000"/>
    <a:srgbClr val="6161FF"/>
    <a:srgbClr val="0000D6"/>
    <a:srgbClr val="6FDE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282" autoAdjust="0"/>
    <p:restoredTop sz="92520" autoAdjust="0"/>
  </p:normalViewPr>
  <p:slideViewPr>
    <p:cSldViewPr snapToGrid="0">
      <p:cViewPr varScale="1">
        <p:scale>
          <a:sx n="112" d="100"/>
          <a:sy n="112" d="100"/>
        </p:scale>
        <p:origin x="47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M:\Cau%20truc%20bai%20viet%20moi\Bai%20genome%20comparatives%20%5bMS2%5d\WebMGA%20COG%20analysis%20extracted%20from%20BPGA%20data\WebMGA%20for%201415core%20936assessory%20129SGs%20from%20EDGA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094124305176572"/>
          <c:y val="5.0925925925925923E-2"/>
          <c:w val="0.81772227772648276"/>
          <c:h val="0.7933848002372667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Whole WFLU12 faa 0.001'!$E$26</c:f>
              <c:strCache>
                <c:ptCount val="1"/>
                <c:pt idx="0">
                  <c:v>classified</c:v>
                </c:pt>
              </c:strCache>
            </c:strRef>
          </c:tx>
          <c:spPr>
            <a:solidFill>
              <a:srgbClr val="2BAB2B"/>
            </a:solidFill>
            <a:ln>
              <a:noFill/>
            </a:ln>
            <a:effectLst/>
          </c:spPr>
          <c:invertIfNegative val="0"/>
          <c:cat>
            <c:strRef>
              <c:f>'Whole WFLU12 faa 0.001'!$F$25:$H$25</c:f>
              <c:strCache>
                <c:ptCount val="3"/>
                <c:pt idx="0">
                  <c:v>core</c:v>
                </c:pt>
                <c:pt idx="1">
                  <c:v>dispensable</c:v>
                </c:pt>
                <c:pt idx="2">
                  <c:v>singleton</c:v>
                </c:pt>
              </c:strCache>
            </c:strRef>
          </c:cat>
          <c:val>
            <c:numRef>
              <c:f>'Whole WFLU12 faa 0.001'!$F$26:$H$26</c:f>
              <c:numCache>
                <c:formatCode>General</c:formatCode>
                <c:ptCount val="3"/>
                <c:pt idx="0">
                  <c:v>1337</c:v>
                </c:pt>
                <c:pt idx="1">
                  <c:v>536</c:v>
                </c:pt>
                <c:pt idx="2">
                  <c:v>49</c:v>
                </c:pt>
              </c:numCache>
            </c:numRef>
          </c:val>
        </c:ser>
        <c:ser>
          <c:idx val="1"/>
          <c:order val="1"/>
          <c:tx>
            <c:strRef>
              <c:f>'Whole WFLU12 faa 0.001'!$E$27</c:f>
              <c:strCache>
                <c:ptCount val="1"/>
                <c:pt idx="0">
                  <c:v>not classified</c:v>
                </c:pt>
              </c:strCache>
            </c:strRef>
          </c:tx>
          <c:spPr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Whole WFLU12 faa 0.001'!$F$25:$H$25</c:f>
              <c:strCache>
                <c:ptCount val="3"/>
                <c:pt idx="0">
                  <c:v>core</c:v>
                </c:pt>
                <c:pt idx="1">
                  <c:v>dispensable</c:v>
                </c:pt>
                <c:pt idx="2">
                  <c:v>singleton</c:v>
                </c:pt>
              </c:strCache>
            </c:strRef>
          </c:cat>
          <c:val>
            <c:numRef>
              <c:f>'Whole WFLU12 faa 0.001'!$F$27:$H$27</c:f>
              <c:numCache>
                <c:formatCode>General</c:formatCode>
                <c:ptCount val="3"/>
                <c:pt idx="0">
                  <c:v>78</c:v>
                </c:pt>
                <c:pt idx="1">
                  <c:v>400</c:v>
                </c:pt>
                <c:pt idx="2">
                  <c:v>8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9343928"/>
        <c:axId val="389343536"/>
      </c:barChart>
      <c:catAx>
        <c:axId val="38934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89343536"/>
        <c:crosses val="autoZero"/>
        <c:auto val="1"/>
        <c:lblAlgn val="ctr"/>
        <c:lblOffset val="100"/>
        <c:noMultiLvlLbl val="0"/>
      </c:catAx>
      <c:valAx>
        <c:axId val="389343536"/>
        <c:scaling>
          <c:orientation val="minMax"/>
          <c:max val="16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 smtClean="0">
                    <a:solidFill>
                      <a:schemeClr val="tx1"/>
                    </a:solidFill>
                    <a:latin typeface="+mn-lt"/>
                    <a:cs typeface="Times New Roman" panose="02020603050405020304" pitchFamily="18" charset="0"/>
                  </a:rPr>
                  <a:t>No. of genes</a:t>
                </a:r>
                <a:endParaRPr lang="en-US" sz="1600" dirty="0">
                  <a:solidFill>
                    <a:schemeClr val="tx1"/>
                  </a:solidFill>
                  <a:latin typeface="+mn-lt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48224936817636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89343928"/>
        <c:crosses val="autoZero"/>
        <c:crossBetween val="between"/>
        <c:majorUnit val="4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455010715818351"/>
          <c:y val="8.5122549703036551E-2"/>
          <c:w val="0.31466874830444247"/>
          <c:h val="0.221065908428113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E02ACA-8E2E-4639-BAFA-FA94014E4029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3B6966-CDC9-4BB9-B470-B33436914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6047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224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863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046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605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205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965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613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997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062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8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164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60A2CA-0822-41CE-9A53-D656AC78BAE2}" type="datetimeFigureOut">
              <a:rPr lang="en-US" smtClean="0"/>
              <a:t>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C8AADE-C9F5-4F01-85EE-EAAE02D2A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387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1047584"/>
              </p:ext>
            </p:extLst>
          </p:nvPr>
        </p:nvGraphicFramePr>
        <p:xfrm>
          <a:off x="998680" y="3333340"/>
          <a:ext cx="4751387" cy="31559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998680" y="191592"/>
            <a:ext cx="3712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cs typeface="Times New Roman" panose="02020603050405020304" pitchFamily="18" charset="0"/>
              </a:rPr>
              <a:t>A</a:t>
            </a:r>
            <a:endParaRPr lang="en-US" sz="2000" b="1" dirty="0"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268657" y="176981"/>
            <a:ext cx="3712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cs typeface="Times New Roman" panose="02020603050405020304" pitchFamily="18" charset="0"/>
              </a:rPr>
              <a:t>B</a:t>
            </a:r>
            <a:endParaRPr lang="en-US" sz="2000" b="1" dirty="0"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-1549703"/>
            <a:ext cx="1222044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1.</a:t>
            </a:r>
            <a:r>
              <a:rPr lang="en-US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unctional annotation</a:t>
            </a:r>
            <a:r>
              <a:rPr lang="en-US" sz="2000" dirty="0"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f </a:t>
            </a:r>
            <a:r>
              <a:rPr lang="en-US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rtholog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groups in the different parts of pan-genome of strain WFLU12. (A) Distribution of </a:t>
            </a:r>
            <a:r>
              <a:rPr lang="en-US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rtholog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groups, functionally annotated and not annotated using search in the COG database in the different parts of the pan-genome. (B) Scaled </a:t>
            </a:r>
            <a:r>
              <a:rPr lang="en-US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heatmap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of the distribution of the functional classes among the different parts of pan-genome.</a:t>
            </a:r>
            <a:endParaRPr lang="en-US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7" name="Rectangle 16"/>
          <p:cNvSpPr/>
          <p:nvPr/>
        </p:nvSpPr>
        <p:spPr>
          <a:xfrm rot="16200000">
            <a:off x="6920463" y="1992922"/>
            <a:ext cx="1025081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 smtClean="0">
                <a:ea typeface="Malgun Gothic" panose="020B0503020000020004" pitchFamily="34" charset="-127"/>
                <a:cs typeface="Times New Roman" panose="02020603050405020304" pitchFamily="18" charset="0"/>
              </a:rPr>
              <a:t>Core</a:t>
            </a:r>
            <a:endParaRPr lang="en-US" sz="1400" b="1" dirty="0"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" name="Rectangle 17"/>
          <p:cNvSpPr/>
          <p:nvPr/>
        </p:nvSpPr>
        <p:spPr>
          <a:xfrm rot="16200000">
            <a:off x="7228599" y="1879314"/>
            <a:ext cx="1268558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 smtClean="0">
                <a:ea typeface="Malgun Gothic" panose="020B0503020000020004" pitchFamily="34" charset="-127"/>
                <a:cs typeface="Times New Roman" panose="02020603050405020304" pitchFamily="18" charset="0"/>
              </a:rPr>
              <a:t>Dispensable</a:t>
            </a:r>
            <a:endParaRPr lang="en-US" sz="1400" b="1" dirty="0"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21" name="Rectangle 20"/>
          <p:cNvSpPr/>
          <p:nvPr/>
        </p:nvSpPr>
        <p:spPr>
          <a:xfrm rot="16200000">
            <a:off x="7782302" y="1995709"/>
            <a:ext cx="1035772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 smtClean="0">
                <a:ea typeface="Malgun Gothic" panose="020B0503020000020004" pitchFamily="34" charset="-127"/>
                <a:cs typeface="Times New Roman" panose="02020603050405020304" pitchFamily="18" charset="0"/>
              </a:rPr>
              <a:t>Singleton</a:t>
            </a:r>
            <a:endParaRPr lang="en-US" sz="1400" b="1" dirty="0"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150" r="58384"/>
          <a:stretch/>
        </p:blipFill>
        <p:spPr>
          <a:xfrm>
            <a:off x="5874864" y="2698955"/>
            <a:ext cx="2708697" cy="3967316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734" b="78925"/>
          <a:stretch/>
        </p:blipFill>
        <p:spPr>
          <a:xfrm>
            <a:off x="5869903" y="176981"/>
            <a:ext cx="5029156" cy="1445342"/>
          </a:xfrm>
          <a:prstGeom prst="rect">
            <a:avLst/>
          </a:prstGeom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2157839"/>
              </p:ext>
            </p:extLst>
          </p:nvPr>
        </p:nvGraphicFramePr>
        <p:xfrm>
          <a:off x="7283857" y="2699749"/>
          <a:ext cx="1284957" cy="3789540"/>
        </p:xfrm>
        <a:graphic>
          <a:graphicData uri="http://schemas.openxmlformats.org/drawingml/2006/table">
            <a:tbl>
              <a:tblPr/>
              <a:tblGrid>
                <a:gridCol w="428319"/>
                <a:gridCol w="428319"/>
                <a:gridCol w="428319"/>
              </a:tblGrid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5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3071988"/>
              </p:ext>
            </p:extLst>
          </p:nvPr>
        </p:nvGraphicFramePr>
        <p:xfrm>
          <a:off x="8596466" y="2714504"/>
          <a:ext cx="4573844" cy="3774780"/>
        </p:xfrm>
        <a:graphic>
          <a:graphicData uri="http://schemas.openxmlformats.org/drawingml/2006/table">
            <a:tbl>
              <a:tblPr/>
              <a:tblGrid>
                <a:gridCol w="4573844"/>
              </a:tblGrid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ergy production and conversion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condary metabolites biosynthesis, transport and catabolism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ohydrate transport and metabolism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wall/membrane/envelope biogenesis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cycle control, cell division, chromosome partitioning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ino acid transport and metabolism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cleotide transport and metabolism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enzyme transport and metabolism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lation, ribosomal structure and biogenesis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pid transport and metabolism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translational modification, protein turnover, chaperones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cription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ense mechanisms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plication, recombination and repair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motility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organic ion transport and metabolism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nal transduction mechanisms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racellular trafficking, secretion, and vesicular transport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487539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10072893" y="2630774"/>
            <a:ext cx="1176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schemeClr val="accent2"/>
                </a:solidFill>
                <a:cs typeface="Times New Roman" panose="02020603050405020304" pitchFamily="18" charset="0"/>
              </a:rPr>
              <a:t>KF147</a:t>
            </a:r>
            <a:endParaRPr lang="en-US" sz="1600" dirty="0">
              <a:solidFill>
                <a:schemeClr val="accent2"/>
              </a:solidFill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0079681" y="2842478"/>
            <a:ext cx="1176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schemeClr val="accent2"/>
                </a:solidFill>
                <a:cs typeface="Times New Roman" panose="02020603050405020304" pitchFamily="18" charset="0"/>
              </a:rPr>
              <a:t>NCDO2118</a:t>
            </a:r>
            <a:endParaRPr lang="en-US" sz="1600" dirty="0">
              <a:solidFill>
                <a:schemeClr val="accent2"/>
              </a:solidFill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0075252" y="2432000"/>
            <a:ext cx="1176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solidFill>
                  <a:srgbClr val="FF0000"/>
                </a:solidFill>
                <a:cs typeface="Times New Roman" panose="02020603050405020304" pitchFamily="18" charset="0"/>
              </a:rPr>
              <a:t>WFLU12</a:t>
            </a:r>
            <a:endParaRPr lang="en-US" sz="1600" b="1" dirty="0">
              <a:solidFill>
                <a:srgbClr val="FF0000"/>
              </a:solidFill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0079681" y="3027760"/>
            <a:ext cx="1176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schemeClr val="accent2"/>
                </a:solidFill>
                <a:cs typeface="Times New Roman" panose="02020603050405020304" pitchFamily="18" charset="0"/>
              </a:rPr>
              <a:t>AI-06</a:t>
            </a:r>
            <a:endParaRPr lang="en-US" sz="1600" dirty="0">
              <a:solidFill>
                <a:schemeClr val="accent2"/>
              </a:solidFill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0083821" y="3229576"/>
            <a:ext cx="1176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srgbClr val="A50021"/>
                </a:solidFill>
                <a:cs typeface="Times New Roman" panose="02020603050405020304" pitchFamily="18" charset="0"/>
              </a:rPr>
              <a:t>UC08</a:t>
            </a:r>
            <a:endParaRPr lang="en-US" sz="1600" dirty="0">
              <a:solidFill>
                <a:srgbClr val="A50021"/>
              </a:solidFill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0079681" y="3410510"/>
            <a:ext cx="1176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srgbClr val="A50021"/>
                </a:solidFill>
                <a:cs typeface="Times New Roman" panose="02020603050405020304" pitchFamily="18" charset="0"/>
              </a:rPr>
              <a:t>UC11</a:t>
            </a:r>
            <a:endParaRPr lang="en-US" sz="1600" dirty="0">
              <a:solidFill>
                <a:srgbClr val="A50021"/>
              </a:solidFill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0079681" y="3613913"/>
            <a:ext cx="1176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UC06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0079681" y="3990934"/>
            <a:ext cx="1176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srgbClr val="00B050"/>
                </a:solidFill>
                <a:cs typeface="Times New Roman" panose="02020603050405020304" pitchFamily="18" charset="0"/>
              </a:rPr>
              <a:t>IO-01</a:t>
            </a:r>
            <a:endParaRPr lang="en-US" sz="1600" dirty="0">
              <a:solidFill>
                <a:srgbClr val="00B050"/>
              </a:solidFill>
              <a:cs typeface="Times New Roman" panose="02020603050405020304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0088706" y="5686056"/>
            <a:ext cx="11649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KLDS4.0325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0080870" y="4361735"/>
            <a:ext cx="1028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IL1403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0079681" y="4177197"/>
            <a:ext cx="1028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UC77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0077322" y="4751405"/>
            <a:ext cx="1028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UC63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0088706" y="5133795"/>
            <a:ext cx="1028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C10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0102129" y="5327250"/>
            <a:ext cx="6806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UL8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0083821" y="4931778"/>
            <a:ext cx="6806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275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0092679" y="5502295"/>
            <a:ext cx="6717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184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0102129" y="5890973"/>
            <a:ext cx="6806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CV56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0082925" y="3800463"/>
            <a:ext cx="1026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S0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0079681" y="4568242"/>
            <a:ext cx="1026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229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0102129" y="6074639"/>
            <a:ext cx="7800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cs typeface="Times New Roman" panose="02020603050405020304" pitchFamily="18" charset="0"/>
              </a:rPr>
              <a:t>A12</a:t>
            </a:r>
            <a:endParaRPr lang="en-US" sz="1600" dirty="0"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2" t="49083" r="11946" b="2453"/>
          <a:stretch/>
        </p:blipFill>
        <p:spPr>
          <a:xfrm>
            <a:off x="192382" y="2432050"/>
            <a:ext cx="9960547" cy="3998486"/>
          </a:xfrm>
          <a:prstGeom prst="rect">
            <a:avLst/>
          </a:prstGeom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3743715"/>
              </p:ext>
            </p:extLst>
          </p:nvPr>
        </p:nvGraphicFramePr>
        <p:xfrm>
          <a:off x="2455816" y="2495156"/>
          <a:ext cx="7605556" cy="3830040"/>
        </p:xfrm>
        <a:graphic>
          <a:graphicData uri="http://schemas.openxmlformats.org/drawingml/2006/table">
            <a:tbl>
              <a:tblPr/>
              <a:tblGrid>
                <a:gridCol w="352416"/>
                <a:gridCol w="378849"/>
                <a:gridCol w="387658"/>
                <a:gridCol w="378848"/>
                <a:gridCol w="387658"/>
                <a:gridCol w="415536"/>
                <a:gridCol w="370038"/>
                <a:gridCol w="359782"/>
                <a:gridCol w="396468"/>
                <a:gridCol w="361228"/>
                <a:gridCol w="378848"/>
                <a:gridCol w="405280"/>
                <a:gridCol w="361227"/>
                <a:gridCol w="415536"/>
                <a:gridCol w="378848"/>
                <a:gridCol w="370038"/>
                <a:gridCol w="405280"/>
                <a:gridCol w="377385"/>
                <a:gridCol w="380312"/>
                <a:gridCol w="344321"/>
              </a:tblGrid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15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6" t="7214" r="11401" b="68419"/>
          <a:stretch/>
        </p:blipFill>
        <p:spPr>
          <a:xfrm>
            <a:off x="286870" y="442445"/>
            <a:ext cx="9960547" cy="1465962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42" t="-100" r="27156" b="92184"/>
          <a:stretch/>
        </p:blipFill>
        <p:spPr>
          <a:xfrm>
            <a:off x="3202290" y="6382416"/>
            <a:ext cx="5323806" cy="417226"/>
          </a:xfrm>
          <a:prstGeom prst="rect">
            <a:avLst/>
          </a:prstGeom>
        </p:spPr>
      </p:pic>
      <p:graphicFrame>
        <p:nvGraphicFramePr>
          <p:cNvPr id="94" name="Table 9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321798"/>
              </p:ext>
            </p:extLst>
          </p:nvPr>
        </p:nvGraphicFramePr>
        <p:xfrm>
          <a:off x="2455820" y="1619644"/>
          <a:ext cx="7605560" cy="796884"/>
        </p:xfrm>
        <a:graphic>
          <a:graphicData uri="http://schemas.openxmlformats.org/drawingml/2006/table">
            <a:tbl>
              <a:tblPr/>
              <a:tblGrid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  <a:gridCol w="380278"/>
              </a:tblGrid>
              <a:tr h="79688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18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2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125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85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92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113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32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67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8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31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115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105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24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28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35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88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9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4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78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36</a:t>
                      </a:r>
                    </a:p>
                  </a:txBody>
                  <a:tcPr marL="7824" marR="7824" marT="7824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0" y="-1135541"/>
            <a:ext cx="12192000" cy="9814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2. 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on-uniform </a:t>
            </a:r>
            <a:r>
              <a:rPr lang="en-US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AZy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profiles analysis of </a:t>
            </a:r>
            <a:r>
              <a:rPr lang="en-US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. </a:t>
            </a:r>
            <a:r>
              <a:rPr lang="en-US" i="1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actis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trains. The numbers of enzyme modules in each genome are shown. Overrepresented (red) and underrepresented modules (blue) are depicted as number of repertoires. Each strain labeled with </a:t>
            </a:r>
            <a:r>
              <a:rPr lang="en-US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olour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coded as indicated in Figure </a:t>
            </a:r>
            <a:r>
              <a:rPr lang="en-US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.</a:t>
            </a:r>
            <a:endParaRPr lang="en-US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10678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35</TotalTime>
  <Words>702</Words>
  <Application>Microsoft Office PowerPoint</Application>
  <PresentationFormat>와이드스크린</PresentationFormat>
  <Paragraphs>520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Malgun Gothic</vt:lpstr>
      <vt:lpstr>Arial</vt:lpstr>
      <vt:lpstr>Calibri</vt:lpstr>
      <vt:lpstr>Calibri Light</vt:lpstr>
      <vt:lpstr>Times New Roman</vt:lpstr>
      <vt:lpstr>Office Theme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uyen Thanh</dc:creator>
  <cp:lastModifiedBy>PKNU</cp:lastModifiedBy>
  <cp:revision>251</cp:revision>
  <dcterms:created xsi:type="dcterms:W3CDTF">2017-08-04T02:24:19Z</dcterms:created>
  <dcterms:modified xsi:type="dcterms:W3CDTF">2018-01-21T08:20:44Z</dcterms:modified>
</cp:coreProperties>
</file>